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6327"/>
  </p:normalViewPr>
  <p:slideViewPr>
    <p:cSldViewPr snapToGrid="0">
      <p:cViewPr varScale="1">
        <p:scale>
          <a:sx n="128" d="100"/>
          <a:sy n="128" d="100"/>
        </p:scale>
        <p:origin x="48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6A47C63-9D02-9546-B67B-DC3CE8240BD5}" type="datetimeFigureOut">
              <a:rPr lang="en-US" smtClean="0"/>
              <a:t>4/12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A331F89-7A6C-9342-A2ED-4E3E79CD82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74898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DBDC91C-1552-6E47-8464-2D5A4C5D201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037232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C7F0B5-78D3-C539-7C41-D5C1448F2BC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F99CA50-394E-B350-9351-4258252E151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2608D0-35A2-0D40-13BD-C2C9AA4F8F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9A151-AC92-704A-BACB-6505DAC7F110}" type="datetimeFigureOut">
              <a:rPr lang="en-US" smtClean="0"/>
              <a:t>4/12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DE52A82-1BB5-712A-1FC3-00E2892E25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3ADBD8-FEBD-15F1-DF00-B8412567B2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F0F81-ADCE-FB46-9BDD-497DDDD168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72129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DD28F9-A9D0-1C61-5C46-A26EAF9194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C1D55EE-D18B-248B-3AA1-2E78D09CB30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1A12A6-8837-88E5-55B1-155AE39A44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9A151-AC92-704A-BACB-6505DAC7F110}" type="datetimeFigureOut">
              <a:rPr lang="en-US" smtClean="0"/>
              <a:t>4/12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8296A0-F40B-2EDA-5EB0-DB3A1B9A6F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2A4E57A-6C16-D6EC-BDD3-7D7DD11812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F0F81-ADCE-FB46-9BDD-497DDDD168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15329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706D40A-B496-B541-BF74-F3699785E4D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CB346B2-271C-38C2-6617-88CDE47C8D8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138ECA4-D893-A7E2-7252-4BA032FEB6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9A151-AC92-704A-BACB-6505DAC7F110}" type="datetimeFigureOut">
              <a:rPr lang="en-US" smtClean="0"/>
              <a:t>4/12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495C62-3764-BC86-AF22-0DE692A8AD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69B07D-6AB4-BB17-10A2-E92CE96189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F0F81-ADCE-FB46-9BDD-497DDDD168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70018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D52C65-9B43-1A49-18D9-0DB072553B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014EC22-7AE0-43CD-7308-06958047DEA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DDF6D23-8F0B-C3D7-55E2-A8D5761668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9A151-AC92-704A-BACB-6505DAC7F110}" type="datetimeFigureOut">
              <a:rPr lang="en-US" smtClean="0"/>
              <a:t>4/12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8668C7-C28A-00F4-3C22-2B72AECD79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EA9CB4-B292-F6E8-3DA1-5DA4E8CE0F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F0F81-ADCE-FB46-9BDD-497DDDD168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36031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C58576-0576-1DF7-4B4D-4E10A32F14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E0A1593-8396-819A-5184-5F36C258C8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4F6FE9-FF93-0AF6-2A65-1C69BEE3A3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9A151-AC92-704A-BACB-6505DAC7F110}" type="datetimeFigureOut">
              <a:rPr lang="en-US" smtClean="0"/>
              <a:t>4/12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F00D9B5-D53F-7A90-A318-BE9A9BA058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722CEF-137B-6971-D818-5741905E74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F0F81-ADCE-FB46-9BDD-497DDDD168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42574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E0DF29-69C8-4EE3-AB84-5195704CD2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8EE7C79-C9CA-5659-098D-C7840B27566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1C38E04-0ED1-D669-03D6-CB8155F76EE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7664853-5714-112E-969B-9F71B99CFD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9A151-AC92-704A-BACB-6505DAC7F110}" type="datetimeFigureOut">
              <a:rPr lang="en-US" smtClean="0"/>
              <a:t>4/12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29F3D49-19E4-4591-4EB1-E55EE1A524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66F87A2-111A-D26A-3FC8-1072ACB91A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F0F81-ADCE-FB46-9BDD-497DDDD168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62405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ABF948-2322-465C-B3A5-742711FAA2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BC5A420-0AC6-E650-A46F-F70AB65B9C5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CCE53FC-8DAB-0BBB-3152-404750F4F35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CBB8159-9510-B28E-D42B-B24EC88B5C5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C975C55-841C-CB73-185C-DEC6AD54FBF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68E9A77-3FB4-15FC-0C22-32B9E0949F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9A151-AC92-704A-BACB-6505DAC7F110}" type="datetimeFigureOut">
              <a:rPr lang="en-US" smtClean="0"/>
              <a:t>4/12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3FD9397-CA91-5470-F325-BFA8068AC8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7314C6D-3517-A6A7-88B0-6ACD869086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F0F81-ADCE-FB46-9BDD-497DDDD168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03685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5EAEBE-4D1D-64A2-1505-DAC2814274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32D2F9E-B63D-D6BF-FDBE-773DF4558B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9A151-AC92-704A-BACB-6505DAC7F110}" type="datetimeFigureOut">
              <a:rPr lang="en-US" smtClean="0"/>
              <a:t>4/12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C14ED8F-3514-4BF7-37D8-1129AC09F8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D2DBDE7-20C0-A525-141E-01D1B9196C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F0F81-ADCE-FB46-9BDD-497DDDD168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42656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234573B-D1DA-7465-8B72-6477F0C33E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9A151-AC92-704A-BACB-6505DAC7F110}" type="datetimeFigureOut">
              <a:rPr lang="en-US" smtClean="0"/>
              <a:t>4/12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083A0AF-0091-74FC-2672-2A6D910F87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ABD759F-33D9-E57B-7BDA-4E4A62CCA4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F0F81-ADCE-FB46-9BDD-497DDDD168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43171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F2CDA0-2244-99E0-98AA-880B7E818C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03A9EBC-11B6-DF43-06E5-855B5217592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2E1157A-56C4-9276-3302-141118B8DB4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ECBA613-7364-87AA-D384-0E49113FDE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9A151-AC92-704A-BACB-6505DAC7F110}" type="datetimeFigureOut">
              <a:rPr lang="en-US" smtClean="0"/>
              <a:t>4/12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ECA56E7-250D-0B39-B57E-F46A7D7213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F5C43FD-63ED-3907-680C-C7B93F1487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F0F81-ADCE-FB46-9BDD-497DDDD168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84439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5229A9-DA53-26A4-6ECE-51FA4A29C2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1A59CD5-0028-338A-0F50-0AAB8858A13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0DFFCE9-69AF-CFEA-458E-65F02D599FF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C056AAB-C8C4-7069-0D18-D7E5E12604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9A151-AC92-704A-BACB-6505DAC7F110}" type="datetimeFigureOut">
              <a:rPr lang="en-US" smtClean="0"/>
              <a:t>4/12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890A250-B4E1-F1D9-7049-C29C97C6C5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28CD157-C92C-1252-ED98-C218CD8083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F0F81-ADCE-FB46-9BDD-497DDDD168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33867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735584A-0620-938A-BF0E-A38036E37E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A7A32AD-0664-5B2C-A9AB-1C1EDD5320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3046474-FA2C-1DE4-4DAE-4937D6D3280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49A151-AC92-704A-BACB-6505DAC7F110}" type="datetimeFigureOut">
              <a:rPr lang="en-US" smtClean="0"/>
              <a:t>4/12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F07C3A2-5FDC-41CC-3424-97650B575BF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B510D3-AE3F-EACB-F73C-6C323AC1887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7F0F81-ADCE-FB46-9BDD-497DDDD168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14062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99AFD081-3EF3-4AB2-BF4A-60300E40B876}"/>
              </a:ext>
            </a:extLst>
          </p:cNvPr>
          <p:cNvGraphicFramePr>
            <a:graphicFrameLocks noGrp="1"/>
          </p:cNvGraphicFramePr>
          <p:nvPr/>
        </p:nvGraphicFramePr>
        <p:xfrm>
          <a:off x="2664811" y="87614"/>
          <a:ext cx="6862378" cy="6174638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4438118">
                  <a:extLst>
                    <a:ext uri="{9D8B030D-6E8A-4147-A177-3AD203B41FA5}">
                      <a16:colId xmlns:a16="http://schemas.microsoft.com/office/drawing/2014/main" val="1317664448"/>
                    </a:ext>
                  </a:extLst>
                </a:gridCol>
                <a:gridCol w="2424260">
                  <a:extLst>
                    <a:ext uri="{9D8B030D-6E8A-4147-A177-3AD203B41FA5}">
                      <a16:colId xmlns:a16="http://schemas.microsoft.com/office/drawing/2014/main" val="1599689662"/>
                    </a:ext>
                  </a:extLst>
                </a:gridCol>
              </a:tblGrid>
              <a:tr h="651493">
                <a:tc gridSpan="2">
                  <a:txBody>
                    <a:bodyPr/>
                    <a:lstStyle/>
                    <a:p>
                      <a:pPr algn="l"/>
                      <a:r>
                        <a:rPr lang="en-US" sz="1100" b="1" dirty="0"/>
                        <a:t>Supplementary Table 2: </a:t>
                      </a:r>
                      <a:r>
                        <a:rPr lang="en-US" sz="1100" b="0" dirty="0"/>
                        <a:t>Summary of Admission to Pediatric Intensive Care Unit</a:t>
                      </a: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l"/>
                      <a:endParaRPr lang="en-US" sz="1000" b="1" dirty="0"/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78143961"/>
                  </a:ext>
                </a:extLst>
              </a:tr>
              <a:tr h="288837">
                <a:tc gridSpan="2">
                  <a:txBody>
                    <a:bodyPr/>
                    <a:lstStyle/>
                    <a:p>
                      <a:pPr algn="ctr"/>
                      <a:r>
                        <a:rPr lang="en-US" sz="1100" b="1" i="1" dirty="0"/>
                        <a:t>Demographics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000" b="1" i="1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461165240"/>
                  </a:ext>
                </a:extLst>
              </a:tr>
              <a:tr h="350138">
                <a:tc>
                  <a:txBody>
                    <a:bodyPr/>
                    <a:lstStyle/>
                    <a:p>
                      <a:pPr algn="l"/>
                      <a:r>
                        <a:rPr lang="en-US" sz="1100" b="0" dirty="0"/>
                        <a:t>Total number of patients requiring PICU level of care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3/31 (10%)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171725949"/>
                  </a:ext>
                </a:extLst>
              </a:tr>
              <a:tr h="350138">
                <a:tc>
                  <a:txBody>
                    <a:bodyPr/>
                    <a:lstStyle/>
                    <a:p>
                      <a:pPr algn="l"/>
                      <a:r>
                        <a:rPr lang="en-US" sz="1100" b="0" dirty="0"/>
                        <a:t>Age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100" dirty="0">
                          <a:effectLst/>
                        </a:rPr>
                        <a:t>Mean = 11.3, Median = 9 years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42951378"/>
                  </a:ext>
                </a:extLst>
              </a:tr>
              <a:tr h="394719">
                <a:tc>
                  <a:txBody>
                    <a:bodyPr/>
                    <a:lstStyle/>
                    <a:p>
                      <a:pPr algn="l"/>
                      <a:r>
                        <a:rPr lang="en-US" sz="1100" b="0" dirty="0"/>
                        <a:t>Biologically Female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100" dirty="0">
                          <a:effectLst/>
                        </a:rPr>
                        <a:t>1/3</a:t>
                      </a:r>
                    </a:p>
                  </a:txBody>
                  <a:tcPr marL="47625" marR="47625" marT="47625" marB="4762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89013895"/>
                  </a:ext>
                </a:extLst>
              </a:tr>
              <a:tr h="394719">
                <a:tc>
                  <a:txBody>
                    <a:bodyPr/>
                    <a:lstStyle/>
                    <a:p>
                      <a:pPr algn="l"/>
                      <a:r>
                        <a:rPr lang="en-US" sz="1100" b="0" dirty="0"/>
                        <a:t>Biologically Male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100" dirty="0">
                          <a:effectLst/>
                        </a:rPr>
                        <a:t>2/3</a:t>
                      </a:r>
                    </a:p>
                  </a:txBody>
                  <a:tcPr marL="47625" marR="47625" marT="47625" marB="4762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728013927"/>
                  </a:ext>
                </a:extLst>
              </a:tr>
              <a:tr h="288837">
                <a:tc gridSpan="2">
                  <a:txBody>
                    <a:bodyPr/>
                    <a:lstStyle/>
                    <a:p>
                      <a:pPr algn="ctr"/>
                      <a:r>
                        <a:rPr lang="en-US" sz="1100" b="1" i="1" dirty="0"/>
                        <a:t>Ethnicity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000" b="1" i="1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961353497"/>
                  </a:ext>
                </a:extLst>
              </a:tr>
              <a:tr h="323328">
                <a:tc>
                  <a:txBody>
                    <a:bodyPr/>
                    <a:lstStyle/>
                    <a:p>
                      <a:pPr algn="l"/>
                      <a:r>
                        <a:rPr lang="en-US" sz="1100" b="0" dirty="0"/>
                        <a:t>White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100" dirty="0"/>
                        <a:t>1/3</a:t>
                      </a:r>
                      <a:endParaRPr lang="en-US" sz="1100" dirty="0">
                        <a:effectLst/>
                      </a:endParaRPr>
                    </a:p>
                  </a:txBody>
                  <a:tcPr marL="47625" marR="47625" marT="47625" marB="4762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668635309"/>
                  </a:ext>
                </a:extLst>
              </a:tr>
              <a:tr h="302440">
                <a:tc>
                  <a:txBody>
                    <a:bodyPr/>
                    <a:lstStyle/>
                    <a:p>
                      <a:pPr algn="l"/>
                      <a:r>
                        <a:rPr lang="en-US" sz="1100" b="0" dirty="0"/>
                        <a:t>Black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100" dirty="0"/>
                        <a:t>1/3</a:t>
                      </a:r>
                      <a:endParaRPr lang="en-US" sz="1100" dirty="0">
                        <a:effectLst/>
                      </a:endParaRPr>
                    </a:p>
                  </a:txBody>
                  <a:tcPr marL="47625" marR="47625" marT="47625" marB="4762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6994381"/>
                  </a:ext>
                </a:extLst>
              </a:tr>
              <a:tr h="301633">
                <a:tc>
                  <a:txBody>
                    <a:bodyPr/>
                    <a:lstStyle/>
                    <a:p>
                      <a:pPr algn="l"/>
                      <a:r>
                        <a:rPr lang="en-US" sz="1100" b="0" dirty="0"/>
                        <a:t>Hispanic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100" dirty="0">
                          <a:effectLst/>
                        </a:rPr>
                        <a:t>1/3</a:t>
                      </a:r>
                    </a:p>
                  </a:txBody>
                  <a:tcPr marL="47625" marR="47625" marT="47625" marB="4762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439162045"/>
                  </a:ext>
                </a:extLst>
              </a:tr>
              <a:tr h="288837">
                <a:tc gridSpan="2">
                  <a:txBody>
                    <a:bodyPr/>
                    <a:lstStyle/>
                    <a:p>
                      <a:pPr algn="ctr"/>
                      <a:r>
                        <a:rPr lang="en-US" sz="1100" b="1" i="1" dirty="0"/>
                        <a:t>Acute Psychopharmacologic Infusions in PICU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000" b="1" i="1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35066470"/>
                  </a:ext>
                </a:extLst>
              </a:tr>
              <a:tr h="293085">
                <a:tc>
                  <a:txBody>
                    <a:bodyPr/>
                    <a:lstStyle/>
                    <a:p>
                      <a:pPr algn="l"/>
                      <a:r>
                        <a:rPr lang="en-US" sz="1100" b="0" dirty="0"/>
                        <a:t>Midazolam dosage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100">
                          <a:effectLst/>
                        </a:rPr>
                        <a:t>Mean = 1.8 mg / hour</a:t>
                      </a:r>
                      <a:endParaRPr lang="en-US" sz="1100" dirty="0">
                        <a:effectLst/>
                      </a:endParaRPr>
                    </a:p>
                  </a:txBody>
                  <a:tcPr marL="47625" marR="47625" marT="47625" marB="4762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45107742"/>
                  </a:ext>
                </a:extLst>
              </a:tr>
              <a:tr h="293085">
                <a:tc>
                  <a:txBody>
                    <a:bodyPr/>
                    <a:lstStyle/>
                    <a:p>
                      <a:pPr algn="l"/>
                      <a:r>
                        <a:rPr lang="en-US" sz="1100" b="0" dirty="0"/>
                        <a:t>Dexmedetomidine dosage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100">
                          <a:effectLst/>
                        </a:rPr>
                        <a:t>Mean = 0.2 mcg / kg / hour</a:t>
                      </a:r>
                      <a:endParaRPr lang="en-US" sz="1100" dirty="0">
                        <a:effectLst/>
                      </a:endParaRPr>
                    </a:p>
                  </a:txBody>
                  <a:tcPr marL="47625" marR="47625" marT="47625" marB="4762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90892495"/>
                  </a:ext>
                </a:extLst>
              </a:tr>
              <a:tr h="288837">
                <a:tc gridSpan="2">
                  <a:txBody>
                    <a:bodyPr/>
                    <a:lstStyle/>
                    <a:p>
                      <a:pPr algn="ctr"/>
                      <a:r>
                        <a:rPr lang="en-US" sz="1100" b="1" i="1" dirty="0"/>
                        <a:t>Oral benzodiazepine dosages following PICU admission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000" b="1" i="1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229116852"/>
                  </a:ext>
                </a:extLst>
              </a:tr>
              <a:tr h="293085">
                <a:tc>
                  <a:txBody>
                    <a:bodyPr/>
                    <a:lstStyle/>
                    <a:p>
                      <a:pPr algn="l"/>
                      <a:r>
                        <a:rPr lang="en-US" sz="1100" b="0" dirty="0"/>
                        <a:t>Total number of patients receiving clonazepam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100" dirty="0">
                          <a:effectLst/>
                        </a:rPr>
                        <a:t>2/3</a:t>
                      </a:r>
                    </a:p>
                  </a:txBody>
                  <a:tcPr marL="47625" marR="47625" marT="47625" marB="47625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30039576"/>
                  </a:ext>
                </a:extLst>
              </a:tr>
              <a:tr h="288837">
                <a:tc>
                  <a:txBody>
                    <a:bodyPr/>
                    <a:lstStyle/>
                    <a:p>
                      <a:pPr algn="l"/>
                      <a:r>
                        <a:rPr lang="en-US" sz="1100" b="0" dirty="0"/>
                        <a:t>Mean total daily dosage of clonazepam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effectLst/>
                          <a:latin typeface="+mn-lt"/>
                        </a:rPr>
                        <a:t>7.5 mg</a:t>
                      </a:r>
                    </a:p>
                  </a:txBody>
                  <a:tcPr marL="38100" marR="38100" marT="38100" marB="381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502465423"/>
                  </a:ext>
                </a:extLst>
              </a:tr>
              <a:tr h="442780">
                <a:tc>
                  <a:txBody>
                    <a:bodyPr/>
                    <a:lstStyle/>
                    <a:p>
                      <a:pPr algn="l"/>
                      <a:r>
                        <a:rPr lang="en-US" sz="1100" b="0" dirty="0"/>
                        <a:t>Total number of patients receiving diazepam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100" dirty="0">
                          <a:effectLst/>
                        </a:rPr>
                        <a:t>1/3</a:t>
                      </a:r>
                    </a:p>
                  </a:txBody>
                  <a:tcPr marL="47625" marR="47625" marT="47625" marB="47625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451218320"/>
                  </a:ext>
                </a:extLst>
              </a:tr>
              <a:tr h="339810">
                <a:tc>
                  <a:txBody>
                    <a:bodyPr/>
                    <a:lstStyle/>
                    <a:p>
                      <a:pPr algn="l"/>
                      <a:r>
                        <a:rPr lang="en-US" sz="1100" b="0" dirty="0"/>
                        <a:t>Total daily dosage of diazepam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effectLst/>
                          <a:latin typeface="+mn-lt"/>
                        </a:rPr>
                        <a:t>180 mg</a:t>
                      </a:r>
                    </a:p>
                  </a:txBody>
                  <a:tcPr marL="38100" marR="38100" marT="38100" marB="381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72870593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5290846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7</Words>
  <Application>Microsoft Macintosh PowerPoint</Application>
  <PresentationFormat>Widescreen</PresentationFormat>
  <Paragraphs>3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mith, Joshua Ryan</dc:creator>
  <cp:lastModifiedBy>Smith, Joshua Ryan</cp:lastModifiedBy>
  <cp:revision>1</cp:revision>
  <dcterms:created xsi:type="dcterms:W3CDTF">2023-04-12T21:16:06Z</dcterms:created>
  <dcterms:modified xsi:type="dcterms:W3CDTF">2023-04-12T21:16:2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792c8cef-6f2b-4af1-b4ac-d815ff795cd6_Enabled">
    <vt:lpwstr>true</vt:lpwstr>
  </property>
  <property fmtid="{D5CDD505-2E9C-101B-9397-08002B2CF9AE}" pid="3" name="MSIP_Label_792c8cef-6f2b-4af1-b4ac-d815ff795cd6_SetDate">
    <vt:lpwstr>2023-04-12T21:16:24Z</vt:lpwstr>
  </property>
  <property fmtid="{D5CDD505-2E9C-101B-9397-08002B2CF9AE}" pid="4" name="MSIP_Label_792c8cef-6f2b-4af1-b4ac-d815ff795cd6_Method">
    <vt:lpwstr>Standard</vt:lpwstr>
  </property>
  <property fmtid="{D5CDD505-2E9C-101B-9397-08002B2CF9AE}" pid="5" name="MSIP_Label_792c8cef-6f2b-4af1-b4ac-d815ff795cd6_Name">
    <vt:lpwstr>VUMC General</vt:lpwstr>
  </property>
  <property fmtid="{D5CDD505-2E9C-101B-9397-08002B2CF9AE}" pid="6" name="MSIP_Label_792c8cef-6f2b-4af1-b4ac-d815ff795cd6_SiteId">
    <vt:lpwstr>ef575030-1424-4ed8-b83c-12c533d879ab</vt:lpwstr>
  </property>
  <property fmtid="{D5CDD505-2E9C-101B-9397-08002B2CF9AE}" pid="7" name="MSIP_Label_792c8cef-6f2b-4af1-b4ac-d815ff795cd6_ActionId">
    <vt:lpwstr>e761eee4-e6e1-4f5f-afda-d5c417a4f731</vt:lpwstr>
  </property>
  <property fmtid="{D5CDD505-2E9C-101B-9397-08002B2CF9AE}" pid="8" name="MSIP_Label_792c8cef-6f2b-4af1-b4ac-d815ff795cd6_ContentBits">
    <vt:lpwstr>0</vt:lpwstr>
  </property>
</Properties>
</file>